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8" d="100"/>
          <a:sy n="108" d="100"/>
        </p:scale>
        <p:origin x="-108" y="-1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36658-D14A-4DB1-9BFB-EA3526E3838E}" type="datetimeFigureOut">
              <a:rPr lang="zh-CN" altLang="en-US" smtClean="0"/>
              <a:t>2014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D3600-F132-47FC-BE2D-64932A54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6101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36658-D14A-4DB1-9BFB-EA3526E3838E}" type="datetimeFigureOut">
              <a:rPr lang="zh-CN" altLang="en-US" smtClean="0"/>
              <a:t>2014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D3600-F132-47FC-BE2D-64932A54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8821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36658-D14A-4DB1-9BFB-EA3526E3838E}" type="datetimeFigureOut">
              <a:rPr lang="zh-CN" altLang="en-US" smtClean="0"/>
              <a:t>2014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D3600-F132-47FC-BE2D-64932A54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2896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36658-D14A-4DB1-9BFB-EA3526E3838E}" type="datetimeFigureOut">
              <a:rPr lang="zh-CN" altLang="en-US" smtClean="0"/>
              <a:t>2014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D3600-F132-47FC-BE2D-64932A54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5199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36658-D14A-4DB1-9BFB-EA3526E3838E}" type="datetimeFigureOut">
              <a:rPr lang="zh-CN" altLang="en-US" smtClean="0"/>
              <a:t>2014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D3600-F132-47FC-BE2D-64932A54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8215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36658-D14A-4DB1-9BFB-EA3526E3838E}" type="datetimeFigureOut">
              <a:rPr lang="zh-CN" altLang="en-US" smtClean="0"/>
              <a:t>2014/5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D3600-F132-47FC-BE2D-64932A54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3509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36658-D14A-4DB1-9BFB-EA3526E3838E}" type="datetimeFigureOut">
              <a:rPr lang="zh-CN" altLang="en-US" smtClean="0"/>
              <a:t>2014/5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D3600-F132-47FC-BE2D-64932A54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2521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36658-D14A-4DB1-9BFB-EA3526E3838E}" type="datetimeFigureOut">
              <a:rPr lang="zh-CN" altLang="en-US" smtClean="0"/>
              <a:t>2014/5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D3600-F132-47FC-BE2D-64932A54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1440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36658-D14A-4DB1-9BFB-EA3526E3838E}" type="datetimeFigureOut">
              <a:rPr lang="zh-CN" altLang="en-US" smtClean="0"/>
              <a:t>2014/5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D3600-F132-47FC-BE2D-64932A54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5284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36658-D14A-4DB1-9BFB-EA3526E3838E}" type="datetimeFigureOut">
              <a:rPr lang="zh-CN" altLang="en-US" smtClean="0"/>
              <a:t>2014/5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D3600-F132-47FC-BE2D-64932A54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075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36658-D14A-4DB1-9BFB-EA3526E3838E}" type="datetimeFigureOut">
              <a:rPr lang="zh-CN" altLang="en-US" smtClean="0"/>
              <a:t>2014/5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D3600-F132-47FC-BE2D-64932A54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7713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D36658-D14A-4DB1-9BFB-EA3526E3838E}" type="datetimeFigureOut">
              <a:rPr lang="zh-CN" altLang="en-US" smtClean="0"/>
              <a:t>2014/5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2D3600-F132-47FC-BE2D-64932A54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691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242173" y="695222"/>
            <a:ext cx="1368152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Acetyl-CoA</a:t>
            </a:r>
          </a:p>
        </p:txBody>
      </p:sp>
      <p:sp>
        <p:nvSpPr>
          <p:cNvPr id="5" name="Rectangle 4"/>
          <p:cNvSpPr/>
          <p:nvPr/>
        </p:nvSpPr>
        <p:spPr>
          <a:xfrm>
            <a:off x="5375920" y="999342"/>
            <a:ext cx="2808312" cy="8454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3-hydroxy-3-methylglutaryl-CoA</a:t>
            </a:r>
          </a:p>
        </p:txBody>
      </p:sp>
      <p:sp>
        <p:nvSpPr>
          <p:cNvPr id="6" name="Rectangle 5"/>
          <p:cNvSpPr/>
          <p:nvPr/>
        </p:nvSpPr>
        <p:spPr>
          <a:xfrm>
            <a:off x="1990145" y="1756729"/>
            <a:ext cx="1872208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err="1">
                <a:solidFill>
                  <a:schemeClr val="tx1"/>
                </a:solidFill>
              </a:rPr>
              <a:t>Acetoacetyl</a:t>
            </a:r>
            <a:r>
              <a:rPr lang="en-US" dirty="0">
                <a:solidFill>
                  <a:schemeClr val="tx1"/>
                </a:solidFill>
              </a:rPr>
              <a:t>-CoA</a:t>
            </a:r>
          </a:p>
        </p:txBody>
      </p:sp>
      <p:sp>
        <p:nvSpPr>
          <p:cNvPr id="7" name="Rectangle 6"/>
          <p:cNvSpPr/>
          <p:nvPr/>
        </p:nvSpPr>
        <p:spPr>
          <a:xfrm>
            <a:off x="5951984" y="2348880"/>
            <a:ext cx="1656184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err="1">
                <a:solidFill>
                  <a:schemeClr val="tx1"/>
                </a:solidFill>
              </a:rPr>
              <a:t>Mevalonic</a:t>
            </a:r>
            <a:r>
              <a:rPr lang="en-US" dirty="0">
                <a:solidFill>
                  <a:schemeClr val="tx1"/>
                </a:solidFill>
              </a:rPr>
              <a:t> acid</a:t>
            </a:r>
          </a:p>
        </p:txBody>
      </p:sp>
      <p:sp>
        <p:nvSpPr>
          <p:cNvPr id="8" name="Rectangle 7"/>
          <p:cNvSpPr/>
          <p:nvPr/>
        </p:nvSpPr>
        <p:spPr>
          <a:xfrm>
            <a:off x="5447928" y="3429000"/>
            <a:ext cx="2664296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Mevalonate-5-phosphate</a:t>
            </a:r>
          </a:p>
        </p:txBody>
      </p:sp>
      <p:sp>
        <p:nvSpPr>
          <p:cNvPr id="9" name="Rectangle 8"/>
          <p:cNvSpPr/>
          <p:nvPr/>
        </p:nvSpPr>
        <p:spPr>
          <a:xfrm>
            <a:off x="5159896" y="4509120"/>
            <a:ext cx="3240360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Mevalonate-5-pyrophosphate</a:t>
            </a:r>
          </a:p>
        </p:txBody>
      </p:sp>
      <p:sp>
        <p:nvSpPr>
          <p:cNvPr id="10" name="Rectangle 9"/>
          <p:cNvSpPr/>
          <p:nvPr/>
        </p:nvSpPr>
        <p:spPr>
          <a:xfrm>
            <a:off x="5159896" y="5589240"/>
            <a:ext cx="3240360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Isopentenyl-5-pyrophosphate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991544" y="5589240"/>
            <a:ext cx="1872208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err="1">
                <a:solidFill>
                  <a:schemeClr val="tx1"/>
                </a:solidFill>
              </a:rPr>
              <a:t>Dimethylallyl</a:t>
            </a:r>
            <a:r>
              <a:rPr lang="en-US" dirty="0">
                <a:solidFill>
                  <a:schemeClr val="tx1"/>
                </a:solidFill>
              </a:rPr>
              <a:t>-PP</a:t>
            </a:r>
          </a:p>
        </p:txBody>
      </p:sp>
      <p:cxnSp>
        <p:nvCxnSpPr>
          <p:cNvPr id="12" name="Straight Arrow Connector 11"/>
          <p:cNvCxnSpPr>
            <a:stCxn id="4" idx="2"/>
            <a:endCxn id="6" idx="0"/>
          </p:cNvCxnSpPr>
          <p:nvPr/>
        </p:nvCxnSpPr>
        <p:spPr>
          <a:xfrm>
            <a:off x="2926249" y="1127271"/>
            <a:ext cx="0" cy="62945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urved Connector 12"/>
          <p:cNvCxnSpPr>
            <a:stCxn id="4" idx="3"/>
            <a:endCxn id="5" idx="1"/>
          </p:cNvCxnSpPr>
          <p:nvPr/>
        </p:nvCxnSpPr>
        <p:spPr>
          <a:xfrm>
            <a:off x="3610326" y="911247"/>
            <a:ext cx="1765595" cy="510837"/>
          </a:xfrm>
          <a:prstGeom prst="curvedConnector3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urved Connector 13"/>
          <p:cNvCxnSpPr>
            <a:stCxn id="6" idx="3"/>
            <a:endCxn id="5" idx="1"/>
          </p:cNvCxnSpPr>
          <p:nvPr/>
        </p:nvCxnSpPr>
        <p:spPr>
          <a:xfrm flipV="1">
            <a:off x="3862354" y="1422083"/>
            <a:ext cx="1513567" cy="550670"/>
          </a:xfrm>
          <a:prstGeom prst="curvedConnector3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>
            <a:stCxn id="5" idx="2"/>
            <a:endCxn id="7" idx="0"/>
          </p:cNvCxnSpPr>
          <p:nvPr/>
        </p:nvCxnSpPr>
        <p:spPr>
          <a:xfrm>
            <a:off x="6780076" y="1844824"/>
            <a:ext cx="0" cy="50405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>
            <a:stCxn id="7" idx="2"/>
            <a:endCxn id="8" idx="0"/>
          </p:cNvCxnSpPr>
          <p:nvPr/>
        </p:nvCxnSpPr>
        <p:spPr>
          <a:xfrm>
            <a:off x="6780076" y="2780928"/>
            <a:ext cx="0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>
            <a:stCxn id="8" idx="2"/>
            <a:endCxn id="9" idx="0"/>
          </p:cNvCxnSpPr>
          <p:nvPr/>
        </p:nvCxnSpPr>
        <p:spPr>
          <a:xfrm>
            <a:off x="6780076" y="3861048"/>
            <a:ext cx="0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>
            <a:stCxn id="9" idx="2"/>
            <a:endCxn id="10" idx="0"/>
          </p:cNvCxnSpPr>
          <p:nvPr/>
        </p:nvCxnSpPr>
        <p:spPr>
          <a:xfrm>
            <a:off x="6780076" y="4941168"/>
            <a:ext cx="0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>
            <a:stCxn id="10" idx="1"/>
            <a:endCxn id="11" idx="3"/>
          </p:cNvCxnSpPr>
          <p:nvPr/>
        </p:nvCxnSpPr>
        <p:spPr>
          <a:xfrm flipH="1">
            <a:off x="3863752" y="5805264"/>
            <a:ext cx="129614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1702114" y="1166664"/>
            <a:ext cx="1369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Thiolase</a:t>
            </a:r>
            <a:r>
              <a:rPr lang="en-US" b="1" dirty="0"/>
              <a:t>(1)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935761" y="1918574"/>
            <a:ext cx="14041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MG-CoA synthase(2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789886" y="1918573"/>
            <a:ext cx="24303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MG-CoA </a:t>
            </a:r>
            <a:r>
              <a:rPr lang="en-US" b="1" dirty="0" err="1"/>
              <a:t>reductase</a:t>
            </a:r>
            <a:r>
              <a:rPr lang="en-US" b="1" dirty="0"/>
              <a:t>(6)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789886" y="2915652"/>
            <a:ext cx="24303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Mevalonate</a:t>
            </a:r>
            <a:r>
              <a:rPr lang="en-US" b="1" dirty="0"/>
              <a:t> kinase(1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6789886" y="3995772"/>
            <a:ext cx="3194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Phosphomevalonate</a:t>
            </a:r>
            <a:r>
              <a:rPr lang="en-US" b="1" dirty="0"/>
              <a:t> </a:t>
            </a:r>
            <a:r>
              <a:rPr lang="en-US" b="1" dirty="0" err="1"/>
              <a:t>kinasec</a:t>
            </a:r>
            <a:r>
              <a:rPr lang="en-US" b="1" dirty="0"/>
              <a:t>(1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6789886" y="5075892"/>
            <a:ext cx="33025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Mevalonate-5-pyrophosphate(1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207569" y="6021288"/>
            <a:ext cx="5930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b="1" dirty="0" err="1"/>
              <a:t>Isopentenyl</a:t>
            </a:r>
            <a:r>
              <a:rPr lang="en-SG" b="1" dirty="0"/>
              <a:t> diphosphate (IPP,C5) Delta-</a:t>
            </a:r>
            <a:r>
              <a:rPr lang="en-SG" b="1" dirty="0" err="1"/>
              <a:t>isomerase</a:t>
            </a:r>
            <a:r>
              <a:rPr lang="en-SG" b="1" dirty="0"/>
              <a:t>(2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666109" y="1422083"/>
            <a:ext cx="757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0.03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935761" y="1574483"/>
            <a:ext cx="757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0.45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168009" y="1896271"/>
            <a:ext cx="757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-0.4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6202614" y="2915652"/>
            <a:ext cx="757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1.3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6202614" y="3995772"/>
            <a:ext cx="757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-0.3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6202614" y="5075892"/>
            <a:ext cx="757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0.7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863753" y="5435932"/>
            <a:ext cx="757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6.7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279576" y="1412776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B050"/>
                </a:solidFill>
              </a:rPr>
              <a:t>5.6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583832" y="1556792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B050"/>
                </a:solidFill>
              </a:rPr>
              <a:t>5.9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663952" y="1907540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B050"/>
                </a:solidFill>
              </a:rPr>
              <a:t>6.3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5663952" y="2915652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B050"/>
                </a:solidFill>
              </a:rPr>
              <a:t>4.5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5663952" y="3995772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B050"/>
                </a:solidFill>
              </a:rPr>
              <a:t>2.9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663952" y="5075892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B050"/>
                </a:solidFill>
              </a:rPr>
              <a:t>4.5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367808" y="5435932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B050"/>
                </a:solidFill>
              </a:rPr>
              <a:t>8.4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77301" y="6409604"/>
            <a:ext cx="13965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dditional </a:t>
            </a:r>
            <a:r>
              <a:rPr lang="en-US" sz="1400" b="1"/>
              <a:t>File </a:t>
            </a:r>
            <a:r>
              <a:rPr lang="en-US" sz="1400" b="1" smtClean="0"/>
              <a:t>6</a:t>
            </a:r>
            <a:endParaRPr lang="en-SG" sz="1400" b="1" dirty="0"/>
          </a:p>
        </p:txBody>
      </p:sp>
    </p:spTree>
    <p:extLst>
      <p:ext uri="{BB962C8B-B14F-4D97-AF65-F5344CB8AC3E}">
        <p14:creationId xmlns:p14="http://schemas.microsoft.com/office/powerpoint/2010/main" val="19392835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Office PowerPoint</Application>
  <PresentationFormat>Custom</PresentationFormat>
  <Paragraphs>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金静静</dc:creator>
  <cp:lastModifiedBy>Sarojam Rajani</cp:lastModifiedBy>
  <cp:revision>4</cp:revision>
  <dcterms:created xsi:type="dcterms:W3CDTF">2014-05-23T15:07:54Z</dcterms:created>
  <dcterms:modified xsi:type="dcterms:W3CDTF">2014-05-28T08:00:56Z</dcterms:modified>
</cp:coreProperties>
</file>